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980" r:id="rId2"/>
    <p:sldId id="982" r:id="rId3"/>
    <p:sldId id="981" r:id="rId4"/>
    <p:sldId id="983" r:id="rId5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22" autoAdjust="0"/>
    <p:restoredTop sz="94660"/>
  </p:normalViewPr>
  <p:slideViewPr>
    <p:cSldViewPr snapToGrid="0">
      <p:cViewPr>
        <p:scale>
          <a:sx n="36" d="100"/>
          <a:sy n="36" d="100"/>
        </p:scale>
        <p:origin x="2696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riparna Sen" userId="db13c38c7f1579da" providerId="LiveId" clId="{4B272462-048E-430D-A71D-465D1A8EA17B}"/>
    <pc:docChg chg="delSld">
      <pc:chgData name="Triparna Sen" userId="db13c38c7f1579da" providerId="LiveId" clId="{4B272462-048E-430D-A71D-465D1A8EA17B}" dt="2023-12-25T04:25:15.337" v="2" actId="47"/>
      <pc:docMkLst>
        <pc:docMk/>
      </pc:docMkLst>
      <pc:sldChg chg="del">
        <pc:chgData name="Triparna Sen" userId="db13c38c7f1579da" providerId="LiveId" clId="{4B272462-048E-430D-A71D-465D1A8EA17B}" dt="2023-12-25T04:25:14.415" v="1" actId="47"/>
        <pc:sldMkLst>
          <pc:docMk/>
          <pc:sldMk cId="3960941630" sldId="256"/>
        </pc:sldMkLst>
      </pc:sldChg>
      <pc:sldChg chg="del">
        <pc:chgData name="Triparna Sen" userId="db13c38c7f1579da" providerId="LiveId" clId="{4B272462-048E-430D-A71D-465D1A8EA17B}" dt="2023-12-25T04:25:15.337" v="2" actId="47"/>
        <pc:sldMkLst>
          <pc:docMk/>
          <pc:sldMk cId="4137112076" sldId="257"/>
        </pc:sldMkLst>
      </pc:sldChg>
      <pc:sldChg chg="del">
        <pc:chgData name="Triparna Sen" userId="db13c38c7f1579da" providerId="LiveId" clId="{4B272462-048E-430D-A71D-465D1A8EA17B}" dt="2023-12-25T04:25:13.336" v="0" actId="47"/>
        <pc:sldMkLst>
          <pc:docMk/>
          <pc:sldMk cId="1571759636" sldId="97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tsen\Desktop\CD38%20mRNA%20tumor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SK\Vivo%20excel\CD38\07152020%20vivo%20%20KP11%20chemo%20combo%20pr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SK\Vivo%20excel\CD38\07152020%20vivo%20%20KP11%20chemo%20combo%20pr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1294843962210867E-2"/>
          <c:y val="0.10078117312459728"/>
          <c:w val="0.85652322674822534"/>
          <c:h val="0.788460317611470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6:$C$18</c:f>
                <c:numCache>
                  <c:formatCode>General</c:formatCode>
                  <c:ptCount val="3"/>
                  <c:pt idx="0">
                    <c:v>0.67600000000000005</c:v>
                  </c:pt>
                  <c:pt idx="1">
                    <c:v>0.57679999999999998</c:v>
                  </c:pt>
                  <c:pt idx="2">
                    <c:v>1.0998000000000001</c:v>
                  </c:pt>
                </c:numCache>
              </c:numRef>
            </c:plus>
            <c:minus>
              <c:numRef>
                <c:f>Sheet1!$C$16:$C$18</c:f>
                <c:numCache>
                  <c:formatCode>General</c:formatCode>
                  <c:ptCount val="3"/>
                  <c:pt idx="0">
                    <c:v>0.67600000000000005</c:v>
                  </c:pt>
                  <c:pt idx="1">
                    <c:v>0.57679999999999998</c:v>
                  </c:pt>
                  <c:pt idx="2">
                    <c:v>1.0998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6:$A$18</c:f>
              <c:strCache>
                <c:ptCount val="3"/>
                <c:pt idx="0">
                  <c:v>RP</c:v>
                </c:pt>
                <c:pt idx="1">
                  <c:v>RPP</c:v>
                </c:pt>
                <c:pt idx="2">
                  <c:v>RPM</c:v>
                </c:pt>
              </c:strCache>
            </c:strRef>
          </c:cat>
          <c:val>
            <c:numRef>
              <c:f>Sheet1!$B$16:$B$18</c:f>
              <c:numCache>
                <c:formatCode>General</c:formatCode>
                <c:ptCount val="3"/>
                <c:pt idx="0">
                  <c:v>2.7894000000000001</c:v>
                </c:pt>
                <c:pt idx="1">
                  <c:v>2.0748000000000002</c:v>
                </c:pt>
                <c:pt idx="2">
                  <c:v>5.3697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8C-44BA-8BEF-73BB5BC66C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52116928"/>
        <c:axId val="552117488"/>
      </c:barChart>
      <c:catAx>
        <c:axId val="552116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2117488"/>
        <c:crosses val="autoZero"/>
        <c:auto val="1"/>
        <c:lblAlgn val="ctr"/>
        <c:lblOffset val="100"/>
        <c:noMultiLvlLbl val="0"/>
      </c:catAx>
      <c:valAx>
        <c:axId val="552117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2116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406483583347889"/>
          <c:y val="3.4642831808186142E-2"/>
          <c:w val="0.70055741411543104"/>
          <c:h val="0.76406110185851706"/>
        </c:manualLayout>
      </c:layout>
      <c:lineChart>
        <c:grouping val="standard"/>
        <c:varyColors val="0"/>
        <c:ser>
          <c:idx val="2"/>
          <c:order val="0"/>
          <c:tx>
            <c:v>1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27:$W$27</c:f>
              <c:numCache>
                <c:formatCode>0.0</c:formatCode>
                <c:ptCount val="20"/>
                <c:pt idx="0">
                  <c:v>46.464000000000006</c:v>
                </c:pt>
                <c:pt idx="1">
                  <c:v>44.981999999999999</c:v>
                </c:pt>
                <c:pt idx="2">
                  <c:v>62.207999999999998</c:v>
                </c:pt>
                <c:pt idx="3">
                  <c:v>64.51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47.149499999999989</c:v>
                </c:pt>
                <c:pt idx="11">
                  <c:v>85.176000000000002</c:v>
                </c:pt>
                <c:pt idx="12">
                  <c:v>124.468</c:v>
                </c:pt>
                <c:pt idx="13">
                  <c:v>196.51999999999998</c:v>
                </c:pt>
                <c:pt idx="14">
                  <c:v>265.58600000000001</c:v>
                </c:pt>
                <c:pt idx="15">
                  <c:v>425.92000000000007</c:v>
                </c:pt>
                <c:pt idx="16">
                  <c:v>550.52499999999998</c:v>
                </c:pt>
                <c:pt idx="17">
                  <c:v>698.7684999999999</c:v>
                </c:pt>
                <c:pt idx="18">
                  <c:v>1325.646</c:v>
                </c:pt>
                <c:pt idx="19">
                  <c:v>1886.28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626-4490-906D-C5A431CACB22}"/>
            </c:ext>
          </c:extLst>
        </c:ser>
        <c:ser>
          <c:idx val="0"/>
          <c:order val="1"/>
          <c:tx>
            <c:v>2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28:$W$28</c:f>
              <c:numCache>
                <c:formatCode>0.0</c:formatCode>
                <c:ptCount val="20"/>
                <c:pt idx="0">
                  <c:v>37.6</c:v>
                </c:pt>
                <c:pt idx="1">
                  <c:v>37.926000000000002</c:v>
                </c:pt>
                <c:pt idx="2">
                  <c:v>40.67800000000000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7.216000000000001</c:v>
                </c:pt>
                <c:pt idx="14">
                  <c:v>69.11999999999999</c:v>
                </c:pt>
                <c:pt idx="15">
                  <c:v>89.888000000000005</c:v>
                </c:pt>
                <c:pt idx="16">
                  <c:v>142.22800000000001</c:v>
                </c:pt>
                <c:pt idx="17">
                  <c:v>205.8</c:v>
                </c:pt>
                <c:pt idx="18">
                  <c:v>297.60000000000002</c:v>
                </c:pt>
                <c:pt idx="19">
                  <c:v>343.18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626-4490-906D-C5A431CACB22}"/>
            </c:ext>
          </c:extLst>
        </c:ser>
        <c:ser>
          <c:idx val="1"/>
          <c:order val="2"/>
          <c:tx>
            <c:v>3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29:$W$29</c:f>
              <c:numCache>
                <c:formatCode>0.0</c:formatCode>
                <c:ptCount val="20"/>
                <c:pt idx="0">
                  <c:v>68.478999999999999</c:v>
                </c:pt>
                <c:pt idx="1">
                  <c:v>48.400000000000006</c:v>
                </c:pt>
                <c:pt idx="2">
                  <c:v>53.662499999999994</c:v>
                </c:pt>
                <c:pt idx="3">
                  <c:v>50.42999999999999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65.664000000000001</c:v>
                </c:pt>
                <c:pt idx="15">
                  <c:v>97.344000000000023</c:v>
                </c:pt>
                <c:pt idx="16">
                  <c:v>189.58399999999997</c:v>
                </c:pt>
                <c:pt idx="17">
                  <c:v>280.84500000000003</c:v>
                </c:pt>
                <c:pt idx="18">
                  <c:v>498.67699999999991</c:v>
                </c:pt>
                <c:pt idx="19">
                  <c:v>657.9644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626-4490-906D-C5A431CACB22}"/>
            </c:ext>
          </c:extLst>
        </c:ser>
        <c:ser>
          <c:idx val="3"/>
          <c:order val="3"/>
          <c:tx>
            <c:v>4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31:$W$31</c:f>
              <c:numCache>
                <c:formatCode>0.0</c:formatCode>
                <c:ptCount val="20"/>
                <c:pt idx="0">
                  <c:v>40.572000000000003</c:v>
                </c:pt>
                <c:pt idx="1">
                  <c:v>48.073999999999998</c:v>
                </c:pt>
                <c:pt idx="2">
                  <c:v>47.432000000000009</c:v>
                </c:pt>
                <c:pt idx="3">
                  <c:v>50.783999999999992</c:v>
                </c:pt>
                <c:pt idx="4">
                  <c:v>42.526999999999994</c:v>
                </c:pt>
                <c:pt idx="5">
                  <c:v>39.753499999999995</c:v>
                </c:pt>
                <c:pt idx="6">
                  <c:v>30.419999999999998</c:v>
                </c:pt>
                <c:pt idx="7">
                  <c:v>18</c:v>
                </c:pt>
                <c:pt idx="8">
                  <c:v>17.549999999999997</c:v>
                </c:pt>
                <c:pt idx="9">
                  <c:v>28.749000000000002</c:v>
                </c:pt>
                <c:pt idx="10">
                  <c:v>32</c:v>
                </c:pt>
                <c:pt idx="11">
                  <c:v>23.274999999999999</c:v>
                </c:pt>
                <c:pt idx="12">
                  <c:v>27.380000000000003</c:v>
                </c:pt>
                <c:pt idx="13">
                  <c:v>26.950000000000003</c:v>
                </c:pt>
                <c:pt idx="14">
                  <c:v>27.380000000000003</c:v>
                </c:pt>
                <c:pt idx="15">
                  <c:v>26.695499999999999</c:v>
                </c:pt>
                <c:pt idx="16">
                  <c:v>33.6</c:v>
                </c:pt>
                <c:pt idx="17">
                  <c:v>34.4</c:v>
                </c:pt>
                <c:pt idx="18">
                  <c:v>32</c:v>
                </c:pt>
                <c:pt idx="19">
                  <c:v>36.981999999999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626-4490-906D-C5A431CACB22}"/>
            </c:ext>
          </c:extLst>
        </c:ser>
        <c:ser>
          <c:idx val="4"/>
          <c:order val="4"/>
          <c:tx>
            <c:v>5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32:$W$32</c:f>
              <c:numCache>
                <c:formatCode>0.0</c:formatCode>
                <c:ptCount val="20"/>
                <c:pt idx="0">
                  <c:v>44.527999999999999</c:v>
                </c:pt>
                <c:pt idx="1">
                  <c:v>44.1</c:v>
                </c:pt>
                <c:pt idx="2">
                  <c:v>37.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3.413499999999999</c:v>
                </c:pt>
                <c:pt idx="14">
                  <c:v>81.25</c:v>
                </c:pt>
                <c:pt idx="15">
                  <c:v>91.25</c:v>
                </c:pt>
                <c:pt idx="16">
                  <c:v>198.57500000000002</c:v>
                </c:pt>
                <c:pt idx="17">
                  <c:v>344.45000000000005</c:v>
                </c:pt>
                <c:pt idx="18">
                  <c:v>488.57899999999995</c:v>
                </c:pt>
                <c:pt idx="19">
                  <c:v>925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626-4490-906D-C5A431CACB22}"/>
            </c:ext>
          </c:extLst>
        </c:ser>
        <c:ser>
          <c:idx val="5"/>
          <c:order val="5"/>
          <c:tx>
            <c:v>6</c:v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33:$W$33</c:f>
              <c:numCache>
                <c:formatCode>0.0</c:formatCode>
                <c:ptCount val="20"/>
                <c:pt idx="0">
                  <c:v>59.903999999999996</c:v>
                </c:pt>
                <c:pt idx="1">
                  <c:v>58.189999999999991</c:v>
                </c:pt>
                <c:pt idx="2">
                  <c:v>57.599999999999994</c:v>
                </c:pt>
                <c:pt idx="3">
                  <c:v>57.131999999999998</c:v>
                </c:pt>
                <c:pt idx="4">
                  <c:v>0</c:v>
                </c:pt>
                <c:pt idx="5">
                  <c:v>41.45400000000000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7.549999999999997</c:v>
                </c:pt>
                <c:pt idx="12">
                  <c:v>23.119999999999997</c:v>
                </c:pt>
                <c:pt idx="13">
                  <c:v>44.1</c:v>
                </c:pt>
                <c:pt idx="14">
                  <c:v>60.016000000000012</c:v>
                </c:pt>
                <c:pt idx="15">
                  <c:v>134.01850000000002</c:v>
                </c:pt>
                <c:pt idx="16">
                  <c:v>196.01999999999998</c:v>
                </c:pt>
                <c:pt idx="17">
                  <c:v>252.04999999999998</c:v>
                </c:pt>
                <c:pt idx="18">
                  <c:v>334.98850000000004</c:v>
                </c:pt>
                <c:pt idx="19">
                  <c:v>499.375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626-4490-906D-C5A431CACB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57791384"/>
        <c:axId val="557792696"/>
      </c:lineChart>
      <c:catAx>
        <c:axId val="557791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7792696"/>
        <c:crosses val="autoZero"/>
        <c:auto val="1"/>
        <c:lblAlgn val="ctr"/>
        <c:lblOffset val="100"/>
        <c:noMultiLvlLbl val="0"/>
      </c:catAx>
      <c:valAx>
        <c:axId val="557792696"/>
        <c:scaling>
          <c:orientation val="minMax"/>
          <c:max val="2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 Volume (mm</a:t>
                </a:r>
                <a:r>
                  <a:rPr lang="en-US" sz="1600" baseline="30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7791384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160660544123064"/>
          <c:y val="3.4642831808186142E-2"/>
          <c:w val="0.71290106669351139"/>
          <c:h val="0.76236282734402083"/>
        </c:manualLayout>
      </c:layout>
      <c:lineChart>
        <c:grouping val="standard"/>
        <c:varyColors val="0"/>
        <c:ser>
          <c:idx val="2"/>
          <c:order val="0"/>
          <c:tx>
            <c:v>1</c:v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38:$W$38</c:f>
              <c:numCache>
                <c:formatCode>0.0</c:formatCode>
                <c:ptCount val="20"/>
                <c:pt idx="0">
                  <c:v>62.207999999999998</c:v>
                </c:pt>
                <c:pt idx="1">
                  <c:v>45.3005</c:v>
                </c:pt>
                <c:pt idx="2">
                  <c:v>35.200000000000003</c:v>
                </c:pt>
                <c:pt idx="3">
                  <c:v>43.2</c:v>
                </c:pt>
                <c:pt idx="4">
                  <c:v>0</c:v>
                </c:pt>
                <c:pt idx="5">
                  <c:v>47.628000000000007</c:v>
                </c:pt>
                <c:pt idx="6">
                  <c:v>36.503999999999998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4.400000000000002</c:v>
                </c:pt>
                <c:pt idx="14">
                  <c:v>24.5</c:v>
                </c:pt>
                <c:pt idx="15">
                  <c:v>33.048000000000002</c:v>
                </c:pt>
                <c:pt idx="16">
                  <c:v>44</c:v>
                </c:pt>
                <c:pt idx="17">
                  <c:v>52.272000000000013</c:v>
                </c:pt>
                <c:pt idx="18">
                  <c:v>72.030000000000015</c:v>
                </c:pt>
                <c:pt idx="19">
                  <c:v>70.688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819-4B62-8802-D04F94779557}"/>
            </c:ext>
          </c:extLst>
        </c:ser>
        <c:ser>
          <c:idx val="0"/>
          <c:order val="1"/>
          <c:tx>
            <c:v>2</c:v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39:$W$39</c:f>
              <c:numCache>
                <c:formatCode>0.0</c:formatCode>
                <c:ptCount val="20"/>
                <c:pt idx="0">
                  <c:v>44.8</c:v>
                </c:pt>
                <c:pt idx="1">
                  <c:v>37.264499999999998</c:v>
                </c:pt>
                <c:pt idx="2">
                  <c:v>32.85600000000000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34.225000000000001</c:v>
                </c:pt>
                <c:pt idx="17">
                  <c:v>36.1</c:v>
                </c:pt>
                <c:pt idx="18">
                  <c:v>47.911499999999997</c:v>
                </c:pt>
                <c:pt idx="19">
                  <c:v>72.89999999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819-4B62-8802-D04F94779557}"/>
            </c:ext>
          </c:extLst>
        </c:ser>
        <c:ser>
          <c:idx val="1"/>
          <c:order val="2"/>
          <c:tx>
            <c:v>3</c:v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40:$W$40</c:f>
              <c:numCache>
                <c:formatCode>0.0</c:formatCode>
                <c:ptCount val="20"/>
                <c:pt idx="0">
                  <c:v>78.732000000000014</c:v>
                </c:pt>
                <c:pt idx="1">
                  <c:v>37.926000000000002</c:v>
                </c:pt>
                <c:pt idx="2">
                  <c:v>36.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819-4B62-8802-D04F94779557}"/>
            </c:ext>
          </c:extLst>
        </c:ser>
        <c:ser>
          <c:idx val="3"/>
          <c:order val="3"/>
          <c:tx>
            <c:v>4</c:v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42:$W$42</c:f>
              <c:numCache>
                <c:formatCode>0.0</c:formatCode>
                <c:ptCount val="20"/>
                <c:pt idx="0">
                  <c:v>72.5</c:v>
                </c:pt>
                <c:pt idx="1">
                  <c:v>57.599999999999994</c:v>
                </c:pt>
                <c:pt idx="2">
                  <c:v>40.34399999999998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23.887499999999999</c:v>
                </c:pt>
                <c:pt idx="13">
                  <c:v>38.024999999999999</c:v>
                </c:pt>
                <c:pt idx="14">
                  <c:v>59.643000000000008</c:v>
                </c:pt>
                <c:pt idx="15">
                  <c:v>80.0565</c:v>
                </c:pt>
                <c:pt idx="16">
                  <c:v>122.39999999999999</c:v>
                </c:pt>
                <c:pt idx="17">
                  <c:v>191.1</c:v>
                </c:pt>
                <c:pt idx="18">
                  <c:v>375.584</c:v>
                </c:pt>
                <c:pt idx="19">
                  <c:v>547.428000000000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819-4B62-8802-D04F94779557}"/>
            </c:ext>
          </c:extLst>
        </c:ser>
        <c:ser>
          <c:idx val="4"/>
          <c:order val="4"/>
          <c:tx>
            <c:v>5</c:v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43:$W$43</c:f>
              <c:numCache>
                <c:formatCode>0.0</c:formatCode>
                <c:ptCount val="20"/>
                <c:pt idx="0">
                  <c:v>51.304000000000002</c:v>
                </c:pt>
                <c:pt idx="1">
                  <c:v>54.675000000000004</c:v>
                </c:pt>
                <c:pt idx="2">
                  <c:v>50.847499999999997</c:v>
                </c:pt>
                <c:pt idx="3">
                  <c:v>42.336000000000006</c:v>
                </c:pt>
                <c:pt idx="4">
                  <c:v>45.86400000000001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819-4B62-8802-D04F94779557}"/>
            </c:ext>
          </c:extLst>
        </c:ser>
        <c:ser>
          <c:idx val="5"/>
          <c:order val="5"/>
          <c:tx>
            <c:v>6</c:v>
          </c:tx>
          <c:spPr>
            <a:ln w="28575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cat>
            <c:numRef>
              <c:f>'For Figure'!$D$1:$W$1</c:f>
              <c:numCache>
                <c:formatCode>General</c:formatCode>
                <c:ptCount val="20"/>
                <c:pt idx="0">
                  <c:v>7</c:v>
                </c:pt>
                <c:pt idx="2">
                  <c:v>14</c:v>
                </c:pt>
                <c:pt idx="4">
                  <c:v>21</c:v>
                </c:pt>
                <c:pt idx="6">
                  <c:v>28</c:v>
                </c:pt>
                <c:pt idx="7">
                  <c:v>35</c:v>
                </c:pt>
                <c:pt idx="9">
                  <c:v>42</c:v>
                </c:pt>
                <c:pt idx="11">
                  <c:v>49</c:v>
                </c:pt>
                <c:pt idx="13">
                  <c:v>56</c:v>
                </c:pt>
                <c:pt idx="15">
                  <c:v>63</c:v>
                </c:pt>
                <c:pt idx="17">
                  <c:v>70</c:v>
                </c:pt>
                <c:pt idx="19">
                  <c:v>77</c:v>
                </c:pt>
              </c:numCache>
            </c:numRef>
          </c:cat>
          <c:val>
            <c:numRef>
              <c:f>'For Figure'!$D$44:$W$44</c:f>
              <c:numCache>
                <c:formatCode>0.0</c:formatCode>
                <c:ptCount val="20"/>
                <c:pt idx="0">
                  <c:v>42.4</c:v>
                </c:pt>
                <c:pt idx="1">
                  <c:v>37.6</c:v>
                </c:pt>
                <c:pt idx="2">
                  <c:v>48.073999999999998</c:v>
                </c:pt>
                <c:pt idx="3">
                  <c:v>45.864000000000011</c:v>
                </c:pt>
                <c:pt idx="4">
                  <c:v>63.014399999999988</c:v>
                </c:pt>
                <c:pt idx="5">
                  <c:v>45.6</c:v>
                </c:pt>
                <c:pt idx="6">
                  <c:v>48.073999999999998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7.38000000000000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36.799999999999997</c:v>
                </c:pt>
                <c:pt idx="18">
                  <c:v>45.864000000000011</c:v>
                </c:pt>
                <c:pt idx="19">
                  <c:v>81.9314999999999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819-4B62-8802-D04F94779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57791384"/>
        <c:axId val="557792696"/>
      </c:lineChart>
      <c:catAx>
        <c:axId val="557791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7792696"/>
        <c:crosses val="autoZero"/>
        <c:auto val="1"/>
        <c:lblAlgn val="ctr"/>
        <c:lblOffset val="100"/>
        <c:noMultiLvlLbl val="0"/>
      </c:catAx>
      <c:valAx>
        <c:axId val="557792696"/>
        <c:scaling>
          <c:orientation val="minMax"/>
          <c:max val="20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 Volume (mm</a:t>
                </a:r>
                <a:r>
                  <a:rPr lang="en-US" sz="1600" baseline="30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7791384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267AA1EC-2BCA-4542-B699-CE0DDDD4D8BF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669A9B8-76FA-48B3-BD8A-624CEE7CF4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291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444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65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41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583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15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532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183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84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538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92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331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6499E8-DD32-4F17-A603-CAFEE7344849}" type="datetimeFigureOut">
              <a:rPr lang="en-US" smtClean="0"/>
              <a:t>12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F3FF5-0EAE-4116-B9FF-B73BDA73B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71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7">
            <a:extLst>
              <a:ext uri="{FF2B5EF4-FFF2-40B4-BE49-F238E27FC236}">
                <a16:creationId xmlns:a16="http://schemas.microsoft.com/office/drawing/2014/main" id="{BDFB71D6-A0D6-A8CE-CBC1-5A24E0300F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41" t="52856" r="-100"/>
          <a:stretch/>
        </p:blipFill>
        <p:spPr>
          <a:xfrm>
            <a:off x="1571617" y="5299624"/>
            <a:ext cx="4497858" cy="3308659"/>
          </a:xfrm>
          <a:prstGeom prst="rect">
            <a:avLst/>
          </a:prstGeom>
        </p:spPr>
      </p:pic>
      <p:pic>
        <p:nvPicPr>
          <p:cNvPr id="5" name="Picture 20">
            <a:extLst>
              <a:ext uri="{FF2B5EF4-FFF2-40B4-BE49-F238E27FC236}">
                <a16:creationId xmlns:a16="http://schemas.microsoft.com/office/drawing/2014/main" id="{C9717A84-BEE9-86A3-A022-B0DD1B1C6B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68" t="52401" r="-1"/>
          <a:stretch/>
        </p:blipFill>
        <p:spPr>
          <a:xfrm>
            <a:off x="1525029" y="1160944"/>
            <a:ext cx="4533986" cy="3340503"/>
          </a:xfrm>
          <a:prstGeom prst="rect">
            <a:avLst/>
          </a:prstGeom>
        </p:spPr>
      </p:pic>
      <p:sp>
        <p:nvSpPr>
          <p:cNvPr id="8" name="TextBox 1">
            <a:extLst>
              <a:ext uri="{FF2B5EF4-FFF2-40B4-BE49-F238E27FC236}">
                <a16:creationId xmlns:a16="http://schemas.microsoft.com/office/drawing/2014/main" id="{9FB7F46F-04EE-2531-F2E3-8EB936679B6E}"/>
              </a:ext>
            </a:extLst>
          </p:cNvPr>
          <p:cNvSpPr txBox="1"/>
          <p:nvPr/>
        </p:nvSpPr>
        <p:spPr>
          <a:xfrm>
            <a:off x="706269" y="939581"/>
            <a:ext cx="865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</a:p>
        </p:txBody>
      </p:sp>
      <p:sp>
        <p:nvSpPr>
          <p:cNvPr id="9" name="TextBox 26">
            <a:extLst>
              <a:ext uri="{FF2B5EF4-FFF2-40B4-BE49-F238E27FC236}">
                <a16:creationId xmlns:a16="http://schemas.microsoft.com/office/drawing/2014/main" id="{D75523B2-224C-F81E-E4D3-4FAB9C7DA336}"/>
              </a:ext>
            </a:extLst>
          </p:cNvPr>
          <p:cNvSpPr txBox="1"/>
          <p:nvPr/>
        </p:nvSpPr>
        <p:spPr>
          <a:xfrm>
            <a:off x="4304909" y="871419"/>
            <a:ext cx="975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</a:p>
        </p:txBody>
      </p:sp>
      <p:pic>
        <p:nvPicPr>
          <p:cNvPr id="10" name="Picture 17">
            <a:extLst>
              <a:ext uri="{FF2B5EF4-FFF2-40B4-BE49-F238E27FC236}">
                <a16:creationId xmlns:a16="http://schemas.microsoft.com/office/drawing/2014/main" id="{D9A5FF8B-B7CF-C696-083E-0EAD710737C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7320" t="45327" r="555" b="41565"/>
          <a:stretch/>
        </p:blipFill>
        <p:spPr>
          <a:xfrm>
            <a:off x="5455739" y="1160944"/>
            <a:ext cx="741956" cy="1204683"/>
          </a:xfrm>
          <a:prstGeom prst="rect">
            <a:avLst/>
          </a:prstGeom>
        </p:spPr>
      </p:pic>
      <p:pic>
        <p:nvPicPr>
          <p:cNvPr id="11" name="Picture 20">
            <a:extLst>
              <a:ext uri="{FF2B5EF4-FFF2-40B4-BE49-F238E27FC236}">
                <a16:creationId xmlns:a16="http://schemas.microsoft.com/office/drawing/2014/main" id="{6304FA53-95B0-1341-5026-627AE157FA5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95389"/>
          <a:stretch/>
        </p:blipFill>
        <p:spPr>
          <a:xfrm>
            <a:off x="1392788" y="901463"/>
            <a:ext cx="4672666" cy="323625"/>
          </a:xfrm>
          <a:prstGeom prst="rect">
            <a:avLst/>
          </a:prstGeom>
        </p:spPr>
      </p:pic>
      <p:pic>
        <p:nvPicPr>
          <p:cNvPr id="12" name="Picture 17">
            <a:extLst>
              <a:ext uri="{FF2B5EF4-FFF2-40B4-BE49-F238E27FC236}">
                <a16:creationId xmlns:a16="http://schemas.microsoft.com/office/drawing/2014/main" id="{3DF8DFAA-9058-2F59-EC4A-CE952105503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95482"/>
          <a:stretch/>
        </p:blipFill>
        <p:spPr>
          <a:xfrm>
            <a:off x="1392801" y="4958717"/>
            <a:ext cx="4672653" cy="31705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527C509-155C-B9FD-70FC-EFDAA7B0C57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7320" t="45327" r="555" b="41565"/>
          <a:stretch/>
        </p:blipFill>
        <p:spPr>
          <a:xfrm>
            <a:off x="5455739" y="5194300"/>
            <a:ext cx="741956" cy="1204683"/>
          </a:xfrm>
          <a:prstGeom prst="rect">
            <a:avLst/>
          </a:prstGeom>
        </p:spPr>
      </p:pic>
      <p:sp>
        <p:nvSpPr>
          <p:cNvPr id="14" name="テキスト ボックス 17">
            <a:extLst>
              <a:ext uri="{FF2B5EF4-FFF2-40B4-BE49-F238E27FC236}">
                <a16:creationId xmlns:a16="http://schemas.microsoft.com/office/drawing/2014/main" id="{9E500F89-9D7D-AA41-CEF2-871D49BE04EA}"/>
              </a:ext>
            </a:extLst>
          </p:cNvPr>
          <p:cNvSpPr txBox="1"/>
          <p:nvPr/>
        </p:nvSpPr>
        <p:spPr>
          <a:xfrm>
            <a:off x="-5156" y="232623"/>
            <a:ext cx="1920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9917056-362A-47BD-9CC1-9510D70ABE49}"/>
              </a:ext>
            </a:extLst>
          </p:cNvPr>
          <p:cNvSpPr txBox="1"/>
          <p:nvPr/>
        </p:nvSpPr>
        <p:spPr>
          <a:xfrm>
            <a:off x="1780101" y="667996"/>
            <a:ext cx="341756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udin et al., dataset</a:t>
            </a:r>
          </a:p>
        </p:txBody>
      </p:sp>
      <p:sp>
        <p:nvSpPr>
          <p:cNvPr id="27" name="TextBox 25">
            <a:extLst>
              <a:ext uri="{FF2B5EF4-FFF2-40B4-BE49-F238E27FC236}">
                <a16:creationId xmlns:a16="http://schemas.microsoft.com/office/drawing/2014/main" id="{7BC902F6-4BEA-6B8C-1DF6-DF4733EBC81C}"/>
              </a:ext>
            </a:extLst>
          </p:cNvPr>
          <p:cNvSpPr txBox="1"/>
          <p:nvPr/>
        </p:nvSpPr>
        <p:spPr>
          <a:xfrm>
            <a:off x="1663142" y="4750198"/>
            <a:ext cx="341756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eorge et al., dataset</a:t>
            </a:r>
          </a:p>
        </p:txBody>
      </p:sp>
      <p:sp>
        <p:nvSpPr>
          <p:cNvPr id="28" name="TextBox 1">
            <a:extLst>
              <a:ext uri="{FF2B5EF4-FFF2-40B4-BE49-F238E27FC236}">
                <a16:creationId xmlns:a16="http://schemas.microsoft.com/office/drawing/2014/main" id="{EE1281ED-ED66-89E9-2818-44FE9189BDE9}"/>
              </a:ext>
            </a:extLst>
          </p:cNvPr>
          <p:cNvSpPr txBox="1"/>
          <p:nvPr/>
        </p:nvSpPr>
        <p:spPr>
          <a:xfrm>
            <a:off x="706269" y="5009634"/>
            <a:ext cx="865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</a:p>
        </p:txBody>
      </p:sp>
    </p:spTree>
    <p:extLst>
      <p:ext uri="{BB962C8B-B14F-4D97-AF65-F5344CB8AC3E}">
        <p14:creationId xmlns:p14="http://schemas.microsoft.com/office/powerpoint/2010/main" val="3324413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FD1913-23FB-A01F-9DE3-8056CDBDF8A3}"/>
              </a:ext>
            </a:extLst>
          </p:cNvPr>
          <p:cNvSpPr txBox="1"/>
          <p:nvPr/>
        </p:nvSpPr>
        <p:spPr>
          <a:xfrm>
            <a:off x="376460" y="219712"/>
            <a:ext cx="1184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オブジェクト 22">
            <a:extLst>
              <a:ext uri="{FF2B5EF4-FFF2-40B4-BE49-F238E27FC236}">
                <a16:creationId xmlns:a16="http://schemas.microsoft.com/office/drawing/2014/main" id="{9BC696D4-3676-7401-A04C-4245B767B8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4131746"/>
              </p:ext>
            </p:extLst>
          </p:nvPr>
        </p:nvGraphicFramePr>
        <p:xfrm>
          <a:off x="347667" y="1658726"/>
          <a:ext cx="2322513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72980" imgH="2985428" progId="Prism9.Document">
                  <p:embed/>
                </p:oleObj>
              </mc:Choice>
              <mc:Fallback>
                <p:oleObj name="Prism 9" r:id="rId2" imgW="3872980" imgH="2985428" progId="Prism9.Document">
                  <p:embed/>
                  <p:pic>
                    <p:nvPicPr>
                      <p:cNvPr id="23" name="オブジェクト 22">
                        <a:extLst>
                          <a:ext uri="{FF2B5EF4-FFF2-40B4-BE49-F238E27FC236}">
                            <a16:creationId xmlns:a16="http://schemas.microsoft.com/office/drawing/2014/main" id="{9BC696D4-3676-7401-A04C-4245B767B8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7667" y="1658726"/>
                        <a:ext cx="2322513" cy="179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0FFD85CC-6F39-9E1A-9878-911628CDB2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7819539"/>
              </p:ext>
            </p:extLst>
          </p:nvPr>
        </p:nvGraphicFramePr>
        <p:xfrm>
          <a:off x="2410572" y="1658727"/>
          <a:ext cx="2259012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65007" imgH="2985428" progId="Prism9.Document">
                  <p:embed/>
                </p:oleObj>
              </mc:Choice>
              <mc:Fallback>
                <p:oleObj name="Prism 9" r:id="rId4" imgW="3765007" imgH="2985428" progId="Prism9.Document">
                  <p:embed/>
                  <p:pic>
                    <p:nvPicPr>
                      <p:cNvPr id="27" name="オブジェクト 26">
                        <a:extLst>
                          <a:ext uri="{FF2B5EF4-FFF2-40B4-BE49-F238E27FC236}">
                            <a16:creationId xmlns:a16="http://schemas.microsoft.com/office/drawing/2014/main" id="{0FFD85CC-6F39-9E1A-9878-911628CDB2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10572" y="1658727"/>
                        <a:ext cx="2259012" cy="179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オブジェクト 27">
            <a:extLst>
              <a:ext uri="{FF2B5EF4-FFF2-40B4-BE49-F238E27FC236}">
                <a16:creationId xmlns:a16="http://schemas.microsoft.com/office/drawing/2014/main" id="{49CC8978-A0DF-79B1-6A06-A657D2D32F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7668956"/>
              </p:ext>
            </p:extLst>
          </p:nvPr>
        </p:nvGraphicFramePr>
        <p:xfrm>
          <a:off x="4598987" y="1658726"/>
          <a:ext cx="2259013" cy="179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3765007" imgH="2985428" progId="Prism7.Document">
                  <p:embed/>
                </p:oleObj>
              </mc:Choice>
              <mc:Fallback>
                <p:oleObj name="Prism 7" r:id="rId6" imgW="3765007" imgH="2985428" progId="Prism7.Document">
                  <p:embed/>
                  <p:pic>
                    <p:nvPicPr>
                      <p:cNvPr id="28" name="オブジェクト 27">
                        <a:extLst>
                          <a:ext uri="{FF2B5EF4-FFF2-40B4-BE49-F238E27FC236}">
                            <a16:creationId xmlns:a16="http://schemas.microsoft.com/office/drawing/2014/main" id="{49CC8978-A0DF-79B1-6A06-A657D2D32F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98987" y="1658726"/>
                        <a:ext cx="2259013" cy="179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オブジェクト 34">
            <a:extLst>
              <a:ext uri="{FF2B5EF4-FFF2-40B4-BE49-F238E27FC236}">
                <a16:creationId xmlns:a16="http://schemas.microsoft.com/office/drawing/2014/main" id="{C61A0970-BE7A-6C98-D63F-B793AA01F3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3207060"/>
              </p:ext>
            </p:extLst>
          </p:nvPr>
        </p:nvGraphicFramePr>
        <p:xfrm>
          <a:off x="350842" y="3581189"/>
          <a:ext cx="2262188" cy="1792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3765007" imgH="2985428" progId="Prism7.Document">
                  <p:embed/>
                </p:oleObj>
              </mc:Choice>
              <mc:Fallback>
                <p:oleObj name="Prism 7" r:id="rId8" imgW="3765007" imgH="2985428" progId="Prism7.Document">
                  <p:embed/>
                  <p:pic>
                    <p:nvPicPr>
                      <p:cNvPr id="35" name="オブジェクト 34">
                        <a:extLst>
                          <a:ext uri="{FF2B5EF4-FFF2-40B4-BE49-F238E27FC236}">
                            <a16:creationId xmlns:a16="http://schemas.microsoft.com/office/drawing/2014/main" id="{C61A0970-BE7A-6C98-D63F-B793AA01F3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0842" y="3581189"/>
                        <a:ext cx="2262188" cy="1792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オブジェクト 36">
            <a:extLst>
              <a:ext uri="{FF2B5EF4-FFF2-40B4-BE49-F238E27FC236}">
                <a16:creationId xmlns:a16="http://schemas.microsoft.com/office/drawing/2014/main" id="{D775D427-F695-375D-B7B2-CAD0690A2D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6861279"/>
              </p:ext>
            </p:extLst>
          </p:nvPr>
        </p:nvGraphicFramePr>
        <p:xfrm>
          <a:off x="2410008" y="3581189"/>
          <a:ext cx="2260600" cy="1792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0" imgW="3765007" imgH="2985428" progId="Prism7.Document">
                  <p:embed/>
                </p:oleObj>
              </mc:Choice>
              <mc:Fallback>
                <p:oleObj name="Prism 7" r:id="rId10" imgW="3765007" imgH="2985428" progId="Prism7.Document">
                  <p:embed/>
                  <p:pic>
                    <p:nvPicPr>
                      <p:cNvPr id="37" name="オブジェクト 36">
                        <a:extLst>
                          <a:ext uri="{FF2B5EF4-FFF2-40B4-BE49-F238E27FC236}">
                            <a16:creationId xmlns:a16="http://schemas.microsoft.com/office/drawing/2014/main" id="{D775D427-F695-375D-B7B2-CAD0690A2D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410008" y="3581189"/>
                        <a:ext cx="2260600" cy="1792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8">
            <a:extLst>
              <a:ext uri="{FF2B5EF4-FFF2-40B4-BE49-F238E27FC236}">
                <a16:creationId xmlns:a16="http://schemas.microsoft.com/office/drawing/2014/main" id="{21BC5168-8EDA-C9CB-50EE-A584FCDB1C62}"/>
              </a:ext>
            </a:extLst>
          </p:cNvPr>
          <p:cNvSpPr txBox="1"/>
          <p:nvPr/>
        </p:nvSpPr>
        <p:spPr>
          <a:xfrm rot="10800000">
            <a:off x="221592" y="1509307"/>
            <a:ext cx="353943" cy="197625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  expression 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1BC5168-8EDA-C9CB-50EE-A584FCDB1C62}"/>
              </a:ext>
            </a:extLst>
          </p:cNvPr>
          <p:cNvSpPr txBox="1"/>
          <p:nvPr/>
        </p:nvSpPr>
        <p:spPr>
          <a:xfrm rot="10800000">
            <a:off x="221591" y="3449426"/>
            <a:ext cx="353943" cy="1976250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  expression  </a:t>
            </a:r>
          </a:p>
        </p:txBody>
      </p:sp>
    </p:spTree>
    <p:extLst>
      <p:ext uri="{BB962C8B-B14F-4D97-AF65-F5344CB8AC3E}">
        <p14:creationId xmlns:p14="http://schemas.microsoft.com/office/powerpoint/2010/main" val="2826408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D1C3938-F0EB-7D58-69A4-C615DA3C5FA1}"/>
              </a:ext>
            </a:extLst>
          </p:cNvPr>
          <p:cNvGrpSpPr/>
          <p:nvPr/>
        </p:nvGrpSpPr>
        <p:grpSpPr>
          <a:xfrm>
            <a:off x="1820685" y="970963"/>
            <a:ext cx="2919176" cy="2536449"/>
            <a:chOff x="8457965" y="9124543"/>
            <a:chExt cx="2447645" cy="3058298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43C66803-6D38-6111-F13C-EB037DE7492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09090347"/>
                </p:ext>
              </p:extLst>
            </p:nvPr>
          </p:nvGraphicFramePr>
          <p:xfrm>
            <a:off x="8660878" y="9144000"/>
            <a:ext cx="2244732" cy="30388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70C2EF3-126A-3C75-CCFC-64B26604FA00}"/>
                </a:ext>
              </a:extLst>
            </p:cNvPr>
            <p:cNvSpPr txBox="1"/>
            <p:nvPr/>
          </p:nvSpPr>
          <p:spPr>
            <a:xfrm rot="16200000">
              <a:off x="7262485" y="10320023"/>
              <a:ext cx="2623216" cy="232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RNA expression</a:t>
              </a:r>
            </a:p>
          </p:txBody>
        </p:sp>
        <p:sp>
          <p:nvSpPr>
            <p:cNvPr id="7" name="Right Bracket 6">
              <a:extLst>
                <a:ext uri="{FF2B5EF4-FFF2-40B4-BE49-F238E27FC236}">
                  <a16:creationId xmlns:a16="http://schemas.microsoft.com/office/drawing/2014/main" id="{2EB64338-3A24-D3E8-85CD-D02B37F3DF21}"/>
                </a:ext>
              </a:extLst>
            </p:cNvPr>
            <p:cNvSpPr/>
            <p:nvPr/>
          </p:nvSpPr>
          <p:spPr>
            <a:xfrm rot="16200000">
              <a:off x="9802673" y="8752374"/>
              <a:ext cx="60959" cy="116581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D56BC3B-7A74-26C3-8B7A-0FAB9659CF4A}"/>
                </a:ext>
              </a:extLst>
            </p:cNvPr>
            <p:cNvSpPr txBox="1"/>
            <p:nvPr/>
          </p:nvSpPr>
          <p:spPr>
            <a:xfrm>
              <a:off x="9685337" y="9124543"/>
              <a:ext cx="430308" cy="333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9" name="Right Bracket 8">
              <a:extLst>
                <a:ext uri="{FF2B5EF4-FFF2-40B4-BE49-F238E27FC236}">
                  <a16:creationId xmlns:a16="http://schemas.microsoft.com/office/drawing/2014/main" id="{AD851DB3-D4A7-A32E-8D5B-10F126F269CA}"/>
                </a:ext>
              </a:extLst>
            </p:cNvPr>
            <p:cNvSpPr/>
            <p:nvPr/>
          </p:nvSpPr>
          <p:spPr>
            <a:xfrm rot="16200000">
              <a:off x="10100371" y="9209997"/>
              <a:ext cx="73655" cy="557721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890E08D-5C0C-07B9-80D6-DBFDC3E80CD1}"/>
                </a:ext>
              </a:extLst>
            </p:cNvPr>
            <p:cNvSpPr txBox="1"/>
            <p:nvPr/>
          </p:nvSpPr>
          <p:spPr>
            <a:xfrm>
              <a:off x="9980416" y="9250064"/>
              <a:ext cx="430308" cy="333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11" name="テキスト ボックス 17">
            <a:extLst>
              <a:ext uri="{FF2B5EF4-FFF2-40B4-BE49-F238E27FC236}">
                <a16:creationId xmlns:a16="http://schemas.microsoft.com/office/drawing/2014/main" id="{7A071673-D582-67BA-E8B7-2B8832FABAAC}"/>
              </a:ext>
            </a:extLst>
          </p:cNvPr>
          <p:cNvSpPr txBox="1"/>
          <p:nvPr/>
        </p:nvSpPr>
        <p:spPr>
          <a:xfrm>
            <a:off x="-5156" y="232623"/>
            <a:ext cx="1920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9951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7">
            <a:extLst>
              <a:ext uri="{FF2B5EF4-FFF2-40B4-BE49-F238E27FC236}">
                <a16:creationId xmlns:a16="http://schemas.microsoft.com/office/drawing/2014/main" id="{BB0D3D6A-3790-C948-EB5E-51FA21655392}"/>
              </a:ext>
            </a:extLst>
          </p:cNvPr>
          <p:cNvSpPr txBox="1"/>
          <p:nvPr/>
        </p:nvSpPr>
        <p:spPr>
          <a:xfrm>
            <a:off x="-5156" y="232623"/>
            <a:ext cx="1920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1">
            <a:extLst>
              <a:ext uri="{FF2B5EF4-FFF2-40B4-BE49-F238E27FC236}">
                <a16:creationId xmlns:a16="http://schemas.microsoft.com/office/drawing/2014/main" id="{813A5857-CB97-492C-B59D-4015CFCD99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4893843"/>
              </p:ext>
            </p:extLst>
          </p:nvPr>
        </p:nvGraphicFramePr>
        <p:xfrm>
          <a:off x="552739" y="1524777"/>
          <a:ext cx="5499969" cy="3109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1">
            <a:extLst>
              <a:ext uri="{FF2B5EF4-FFF2-40B4-BE49-F238E27FC236}">
                <a16:creationId xmlns:a16="http://schemas.microsoft.com/office/drawing/2014/main" id="{9E6EE950-BF09-428B-85BB-EDAC6F2989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4370731"/>
              </p:ext>
            </p:extLst>
          </p:nvPr>
        </p:nvGraphicFramePr>
        <p:xfrm>
          <a:off x="552450" y="5900835"/>
          <a:ext cx="5505450" cy="3109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3F5C38A-8399-0252-0925-30F3BAD6A7C0}"/>
              </a:ext>
            </a:extLst>
          </p:cNvPr>
          <p:cNvSpPr txBox="1"/>
          <p:nvPr/>
        </p:nvSpPr>
        <p:spPr>
          <a:xfrm>
            <a:off x="1914875" y="838200"/>
            <a:ext cx="38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DP+ET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204A066-FDFD-863F-96D0-5EBE5A03A3E7}"/>
              </a:ext>
            </a:extLst>
          </p:cNvPr>
          <p:cNvSpPr txBox="1"/>
          <p:nvPr/>
        </p:nvSpPr>
        <p:spPr>
          <a:xfrm>
            <a:off x="1914874" y="5371971"/>
            <a:ext cx="3895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DP+ETP+αPD-L1+αCD3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2854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95</TotalTime>
  <Words>54</Words>
  <Application>Microsoft Office PowerPoint</Application>
  <PresentationFormat>A4 Paper (210x297 mm)</PresentationFormat>
  <Paragraphs>2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9</vt:lpstr>
      <vt:lpstr>Prism 7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n, Triparna/Medicine</dc:creator>
  <cp:lastModifiedBy>Triparna Sen</cp:lastModifiedBy>
  <cp:revision>49</cp:revision>
  <cp:lastPrinted>2023-08-16T21:06:37Z</cp:lastPrinted>
  <dcterms:created xsi:type="dcterms:W3CDTF">2021-03-24T21:40:06Z</dcterms:created>
  <dcterms:modified xsi:type="dcterms:W3CDTF">2023-12-25T04:25:22Z</dcterms:modified>
</cp:coreProperties>
</file>